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61" r:id="rId2"/>
    <p:sldId id="258" r:id="rId3"/>
    <p:sldId id="256" r:id="rId4"/>
    <p:sldId id="260" r:id="rId5"/>
  </p:sldIdLst>
  <p:sldSz cx="6858000" cy="12192000"/>
  <p:notesSz cx="9944100" cy="6805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E19008F-74F5-A0E3-AC4F-ACDD82F2540E}" name="Penninx, B.W.J.H. (Brenda)" initials="PB" userId="S::b.penninx@amsterdamumc.nl::d5ea70f0-ce35-4b30-ac53-28c3c1a0b362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E3DED36-790D-4C94-A6B3-2D78CBE2B918}" v="1" dt="2026-04-30T09:25:47.32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Geen stijl, tabel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0" autoAdjust="0"/>
    <p:restoredTop sz="93963" autoAdjust="0"/>
  </p:normalViewPr>
  <p:slideViewPr>
    <p:cSldViewPr snapToGrid="0">
      <p:cViewPr>
        <p:scale>
          <a:sx n="80" d="100"/>
          <a:sy n="80" d="100"/>
        </p:scale>
        <p:origin x="177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9110" cy="3414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 dirty="0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5632689" y="0"/>
            <a:ext cx="4309110" cy="3414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A9458F-3A92-45C4-89E5-5298B1030A27}" type="datetimeFigureOut">
              <a:rPr lang="nl-NL" smtClean="0"/>
              <a:t>10-7-2026</a:t>
            </a:fld>
            <a:endParaRPr lang="nl-NL" dirty="0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4325938" y="850900"/>
            <a:ext cx="1292225" cy="22971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 dirty="0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994411" y="3275201"/>
            <a:ext cx="7955279" cy="267971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1" y="6464152"/>
            <a:ext cx="4309110" cy="34146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 dirty="0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5632689" y="6464152"/>
            <a:ext cx="4309110" cy="34146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557F1BC-96A4-4D8B-A7C5-58AC3E43D9FF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40068039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>
          <a:xfrm>
            <a:off x="4325938" y="850900"/>
            <a:ext cx="1292225" cy="2297113"/>
          </a:xfrm>
        </p:spPr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57F1BC-96A4-4D8B-A7C5-58AC3E43D9FF}" type="slidenum">
              <a:rPr lang="nl-NL" smtClean="0"/>
              <a:t>1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3645363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>
          <a:xfrm>
            <a:off x="4325938" y="850900"/>
            <a:ext cx="1292225" cy="2297113"/>
          </a:xfrm>
        </p:spPr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b="1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57F1BC-96A4-4D8B-A7C5-58AC3E43D9FF}" type="slidenum">
              <a:rPr lang="nl-NL" smtClean="0"/>
              <a:t>2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04262813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>
          <a:xfrm>
            <a:off x="4325938" y="850900"/>
            <a:ext cx="1292225" cy="2297113"/>
          </a:xfrm>
        </p:spPr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b="0" u="none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57F1BC-96A4-4D8B-A7C5-58AC3E43D9FF}" type="slidenum">
              <a:rPr lang="nl-NL" smtClean="0"/>
              <a:t>3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2450387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>
          <a:xfrm>
            <a:off x="4325938" y="850900"/>
            <a:ext cx="1292225" cy="2297113"/>
          </a:xfrm>
        </p:spPr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b="1" noProof="0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57F1BC-96A4-4D8B-A7C5-58AC3E43D9FF}" type="slidenum">
              <a:rPr lang="nl-NL" smtClean="0"/>
              <a:t>4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41985667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nl-NL"/>
              <a:t>Klikken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F17C-828B-4549-B724-F8DB1B630E71}" type="datetimeFigureOut">
              <a:rPr lang="nl-NL" smtClean="0"/>
              <a:t>10-7-2026</a:t>
            </a:fld>
            <a:endParaRPr lang="nl-NL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BA6B-B4BA-441F-AD3E-C316DAB27195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129947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F17C-828B-4549-B724-F8DB1B630E71}" type="datetimeFigureOut">
              <a:rPr lang="nl-NL" smtClean="0"/>
              <a:t>10-7-2026</a:t>
            </a:fld>
            <a:endParaRPr lang="nl-NL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BA6B-B4BA-441F-AD3E-C316DAB27195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710286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F17C-828B-4549-B724-F8DB1B630E71}" type="datetimeFigureOut">
              <a:rPr lang="nl-NL" smtClean="0"/>
              <a:t>10-7-2026</a:t>
            </a:fld>
            <a:endParaRPr lang="nl-NL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BA6B-B4BA-441F-AD3E-C316DAB27195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5169242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F17C-828B-4549-B724-F8DB1B630E71}" type="datetimeFigureOut">
              <a:rPr lang="nl-NL" smtClean="0"/>
              <a:t>10-7-2026</a:t>
            </a:fld>
            <a:endParaRPr lang="nl-NL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BA6B-B4BA-441F-AD3E-C316DAB27195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537351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F17C-828B-4549-B724-F8DB1B630E71}" type="datetimeFigureOut">
              <a:rPr lang="nl-NL" smtClean="0"/>
              <a:t>10-7-2026</a:t>
            </a:fld>
            <a:endParaRPr lang="nl-NL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BA6B-B4BA-441F-AD3E-C316DAB27195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5750267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F17C-828B-4549-B724-F8DB1B630E71}" type="datetimeFigureOut">
              <a:rPr lang="nl-NL" smtClean="0"/>
              <a:t>10-7-2026</a:t>
            </a:fld>
            <a:endParaRPr lang="nl-NL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BA6B-B4BA-441F-AD3E-C316DAB27195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5946563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F17C-828B-4549-B724-F8DB1B630E71}" type="datetimeFigureOut">
              <a:rPr lang="nl-NL" smtClean="0"/>
              <a:t>10-7-2026</a:t>
            </a:fld>
            <a:endParaRPr lang="nl-NL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BA6B-B4BA-441F-AD3E-C316DAB27195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4126553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F17C-828B-4549-B724-F8DB1B630E71}" type="datetimeFigureOut">
              <a:rPr lang="nl-NL" smtClean="0"/>
              <a:t>10-7-2026</a:t>
            </a:fld>
            <a:endParaRPr lang="nl-NL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BA6B-B4BA-441F-AD3E-C316DAB27195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940550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F17C-828B-4549-B724-F8DB1B630E71}" type="datetimeFigureOut">
              <a:rPr lang="nl-NL" smtClean="0"/>
              <a:t>10-7-2026</a:t>
            </a:fld>
            <a:endParaRPr lang="nl-NL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BA6B-B4BA-441F-AD3E-C316DAB27195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336573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F17C-828B-4549-B724-F8DB1B630E71}" type="datetimeFigureOut">
              <a:rPr lang="nl-NL" smtClean="0"/>
              <a:t>10-7-2026</a:t>
            </a:fld>
            <a:endParaRPr lang="nl-NL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BA6B-B4BA-441F-AD3E-C316DAB27195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011517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nl-NL" dirty="0"/>
              <a:t>Klik op het pictogram als u een afbeelding wilt toevoe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F17C-828B-4549-B724-F8DB1B630E71}" type="datetimeFigureOut">
              <a:rPr lang="nl-NL" smtClean="0"/>
              <a:t>10-7-2026</a:t>
            </a:fld>
            <a:endParaRPr lang="nl-NL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BA6B-B4BA-441F-AD3E-C316DAB27195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41147888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D4CF17C-828B-4549-B724-F8DB1B630E71}" type="datetimeFigureOut">
              <a:rPr lang="nl-NL" smtClean="0"/>
              <a:t>10-7-2026</a:t>
            </a:fld>
            <a:endParaRPr lang="nl-NL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nl-NL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D64BA6B-B4BA-441F-AD3E-C316DAB27195}" type="slidenum">
              <a:rPr lang="nl-NL" smtClean="0"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2353644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sv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sv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svg"/><Relationship Id="rId5" Type="http://schemas.openxmlformats.org/officeDocument/2006/relationships/image" Target="../media/image5.png"/><Relationship Id="rId10" Type="http://schemas.openxmlformats.org/officeDocument/2006/relationships/image" Target="../media/image10.svg"/><Relationship Id="rId4" Type="http://schemas.openxmlformats.org/officeDocument/2006/relationships/image" Target="../media/image4.svg"/><Relationship Id="rId9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sv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sv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10" Type="http://schemas.openxmlformats.org/officeDocument/2006/relationships/image" Target="../media/image20.svg"/><Relationship Id="rId4" Type="http://schemas.openxmlformats.org/officeDocument/2006/relationships/image" Target="../media/image14.png"/><Relationship Id="rId9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kstvak 1">
            <a:extLst>
              <a:ext uri="{FF2B5EF4-FFF2-40B4-BE49-F238E27FC236}">
                <a16:creationId xmlns:a16="http://schemas.microsoft.com/office/drawing/2014/main" id="{5B553D2E-38E3-3BCB-89E7-195A2985D57A}"/>
              </a:ext>
            </a:extLst>
          </p:cNvPr>
          <p:cNvSpPr txBox="1"/>
          <p:nvPr/>
        </p:nvSpPr>
        <p:spPr>
          <a:xfrm>
            <a:off x="-28297" y="4890"/>
            <a:ext cx="10262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</a:t>
            </a:r>
            <a:r>
              <a:rPr lang="nl-NL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nl-NL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</a:p>
        </p:txBody>
      </p:sp>
      <p:pic>
        <p:nvPicPr>
          <p:cNvPr id="4" name="Graphic 3">
            <a:extLst>
              <a:ext uri="{FF2B5EF4-FFF2-40B4-BE49-F238E27FC236}">
                <a16:creationId xmlns:a16="http://schemas.microsoft.com/office/drawing/2014/main" id="{B8972EF8-E1EC-9BE1-9C5B-93A9085C684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333375" y="266500"/>
            <a:ext cx="6191250" cy="5638800"/>
          </a:xfrm>
          <a:prstGeom prst="rect">
            <a:avLst/>
          </a:prstGeom>
        </p:spPr>
      </p:pic>
      <p:sp>
        <p:nvSpPr>
          <p:cNvPr id="5" name="Tekstvak 4">
            <a:extLst>
              <a:ext uri="{FF2B5EF4-FFF2-40B4-BE49-F238E27FC236}">
                <a16:creationId xmlns:a16="http://schemas.microsoft.com/office/drawing/2014/main" id="{61CB7116-0EBE-FA6C-4E3F-138F613C51EE}"/>
              </a:ext>
            </a:extLst>
          </p:cNvPr>
          <p:cNvSpPr txBox="1"/>
          <p:nvPr/>
        </p:nvSpPr>
        <p:spPr>
          <a:xfrm>
            <a:off x="-28297" y="5849779"/>
            <a:ext cx="344606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nl-NL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essment of multicollinearity of all included 18 determinants.</a:t>
            </a:r>
          </a:p>
        </p:txBody>
      </p:sp>
    </p:spTree>
    <p:extLst>
      <p:ext uri="{BB962C8B-B14F-4D97-AF65-F5344CB8AC3E}">
        <p14:creationId xmlns:p14="http://schemas.microsoft.com/office/powerpoint/2010/main" val="42161551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kstvak 5">
            <a:extLst>
              <a:ext uri="{FF2B5EF4-FFF2-40B4-BE49-F238E27FC236}">
                <a16:creationId xmlns:a16="http://schemas.microsoft.com/office/drawing/2014/main" id="{22BB81B5-6C92-F92B-8759-B948D7E2EC14}"/>
              </a:ext>
            </a:extLst>
          </p:cNvPr>
          <p:cNvSpPr txBox="1"/>
          <p:nvPr/>
        </p:nvSpPr>
        <p:spPr>
          <a:xfrm>
            <a:off x="369479" y="27122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kstvak 7">
            <a:extLst>
              <a:ext uri="{FF2B5EF4-FFF2-40B4-BE49-F238E27FC236}">
                <a16:creationId xmlns:a16="http://schemas.microsoft.com/office/drawing/2014/main" id="{7AD8FF53-F2C1-E734-D75A-03984A236520}"/>
              </a:ext>
            </a:extLst>
          </p:cNvPr>
          <p:cNvSpPr txBox="1"/>
          <p:nvPr/>
        </p:nvSpPr>
        <p:spPr>
          <a:xfrm>
            <a:off x="369479" y="580038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" name="Tekstvak 8">
            <a:extLst>
              <a:ext uri="{FF2B5EF4-FFF2-40B4-BE49-F238E27FC236}">
                <a16:creationId xmlns:a16="http://schemas.microsoft.com/office/drawing/2014/main" id="{C43DF692-DC01-0CCB-C6A7-E5704C4573D2}"/>
              </a:ext>
            </a:extLst>
          </p:cNvPr>
          <p:cNvSpPr txBox="1"/>
          <p:nvPr/>
        </p:nvSpPr>
        <p:spPr>
          <a:xfrm>
            <a:off x="363067" y="762144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" name="Vrije vorm: vorm 3">
            <a:extLst>
              <a:ext uri="{FF2B5EF4-FFF2-40B4-BE49-F238E27FC236}">
                <a16:creationId xmlns:a16="http://schemas.microsoft.com/office/drawing/2014/main" id="{483ED620-8F9B-CFF3-0EB3-26C2FA4FD537}"/>
              </a:ext>
            </a:extLst>
          </p:cNvPr>
          <p:cNvSpPr/>
          <p:nvPr/>
        </p:nvSpPr>
        <p:spPr>
          <a:xfrm>
            <a:off x="832766" y="271223"/>
            <a:ext cx="3575461" cy="1952008"/>
          </a:xfrm>
          <a:custGeom>
            <a:avLst/>
            <a:gdLst>
              <a:gd name="connsiteX0" fmla="*/ 0 w 3575461"/>
              <a:gd name="connsiteY0" fmla="*/ 0 h 1952008"/>
              <a:gd name="connsiteX1" fmla="*/ 3575461 w 3575461"/>
              <a:gd name="connsiteY1" fmla="*/ 0 h 1952008"/>
              <a:gd name="connsiteX2" fmla="*/ 3575461 w 3575461"/>
              <a:gd name="connsiteY2" fmla="*/ 1952008 h 1952008"/>
              <a:gd name="connsiteX3" fmla="*/ 0 w 3575461"/>
              <a:gd name="connsiteY3" fmla="*/ 1952008 h 19520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575461" h="1952008">
                <a:moveTo>
                  <a:pt x="0" y="0"/>
                </a:moveTo>
                <a:lnTo>
                  <a:pt x="3575461" y="0"/>
                </a:lnTo>
                <a:lnTo>
                  <a:pt x="3575461" y="1952008"/>
                </a:lnTo>
                <a:lnTo>
                  <a:pt x="0" y="1952008"/>
                </a:lnTo>
                <a:close/>
              </a:path>
            </a:pathLst>
          </a:custGeom>
          <a:solidFill>
            <a:srgbClr val="FFFFFF"/>
          </a:solidFill>
          <a:ln w="8045" cap="rnd">
            <a:noFill/>
            <a:prstDash val="solid"/>
            <a:round/>
          </a:ln>
        </p:spPr>
        <p:txBody>
          <a:bodyPr rtlCol="0" anchor="ctr"/>
          <a:lstStyle/>
          <a:p>
            <a:endParaRPr lang="nl-NL" dirty="0"/>
          </a:p>
        </p:txBody>
      </p:sp>
      <p:pic>
        <p:nvPicPr>
          <p:cNvPr id="10" name="Graphic 9">
            <a:extLst>
              <a:ext uri="{FF2B5EF4-FFF2-40B4-BE49-F238E27FC236}">
                <a16:creationId xmlns:a16="http://schemas.microsoft.com/office/drawing/2014/main" id="{8139A756-9091-15AA-C55F-A177113027B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832766" y="7621441"/>
            <a:ext cx="4175962" cy="3993852"/>
          </a:xfrm>
          <a:prstGeom prst="rect">
            <a:avLst/>
          </a:prstGeom>
        </p:spPr>
      </p:pic>
      <p:pic>
        <p:nvPicPr>
          <p:cNvPr id="11" name="Graphic 10">
            <a:extLst>
              <a:ext uri="{FF2B5EF4-FFF2-40B4-BE49-F238E27FC236}">
                <a16:creationId xmlns:a16="http://schemas.microsoft.com/office/drawing/2014/main" id="{49299897-D05D-AB4F-A280-73E10178D18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rcRect t="7742" b="7742"/>
          <a:stretch/>
        </p:blipFill>
        <p:spPr>
          <a:xfrm>
            <a:off x="832766" y="2923306"/>
            <a:ext cx="4279635" cy="2671485"/>
          </a:xfrm>
          <a:prstGeom prst="rect">
            <a:avLst/>
          </a:prstGeom>
        </p:spPr>
      </p:pic>
      <p:sp>
        <p:nvSpPr>
          <p:cNvPr id="13" name="Tekstvak 12">
            <a:extLst>
              <a:ext uri="{FF2B5EF4-FFF2-40B4-BE49-F238E27FC236}">
                <a16:creationId xmlns:a16="http://schemas.microsoft.com/office/drawing/2014/main" id="{CA45FF14-A411-BE0B-97BE-BF641E9C9FA4}"/>
              </a:ext>
            </a:extLst>
          </p:cNvPr>
          <p:cNvSpPr txBox="1"/>
          <p:nvPr/>
        </p:nvSpPr>
        <p:spPr>
          <a:xfrm>
            <a:off x="346682" y="290754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Tekstvak 1">
            <a:extLst>
              <a:ext uri="{FF2B5EF4-FFF2-40B4-BE49-F238E27FC236}">
                <a16:creationId xmlns:a16="http://schemas.microsoft.com/office/drawing/2014/main" id="{7D56728F-5593-618D-A63F-2C731DFD585C}"/>
              </a:ext>
            </a:extLst>
          </p:cNvPr>
          <p:cNvSpPr txBox="1"/>
          <p:nvPr/>
        </p:nvSpPr>
        <p:spPr>
          <a:xfrm>
            <a:off x="-28297" y="4890"/>
            <a:ext cx="10262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</a:t>
            </a:r>
            <a:r>
              <a:rPr lang="nl-NL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nl-NL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</a:t>
            </a:r>
          </a:p>
        </p:txBody>
      </p:sp>
      <p:pic>
        <p:nvPicPr>
          <p:cNvPr id="76" name="Graphic 75">
            <a:extLst>
              <a:ext uri="{FF2B5EF4-FFF2-40B4-BE49-F238E27FC236}">
                <a16:creationId xmlns:a16="http://schemas.microsoft.com/office/drawing/2014/main" id="{972AB8BB-209B-4A91-6644-364702BC381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832765" y="5800133"/>
            <a:ext cx="3490841" cy="1821308"/>
          </a:xfrm>
          <a:prstGeom prst="rect">
            <a:avLst/>
          </a:prstGeom>
        </p:spPr>
      </p:pic>
      <p:pic>
        <p:nvPicPr>
          <p:cNvPr id="3" name="Graphic 2">
            <a:extLst>
              <a:ext uri="{FF2B5EF4-FFF2-40B4-BE49-F238E27FC236}">
                <a16:creationId xmlns:a16="http://schemas.microsoft.com/office/drawing/2014/main" id="{D55B5450-A7F3-37BC-463F-71D3E6D4EBA1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832766" y="376948"/>
            <a:ext cx="3229356" cy="2527322"/>
          </a:xfrm>
          <a:prstGeom prst="rect">
            <a:avLst/>
          </a:prstGeom>
        </p:spPr>
      </p:pic>
      <p:sp>
        <p:nvSpPr>
          <p:cNvPr id="7" name="Tekstvak 6">
            <a:extLst>
              <a:ext uri="{FF2B5EF4-FFF2-40B4-BE49-F238E27FC236}">
                <a16:creationId xmlns:a16="http://schemas.microsoft.com/office/drawing/2014/main" id="{34345474-DB23-47C8-5796-ABADFFF7B319}"/>
              </a:ext>
            </a:extLst>
          </p:cNvPr>
          <p:cNvSpPr txBox="1"/>
          <p:nvPr/>
        </p:nvSpPr>
        <p:spPr>
          <a:xfrm>
            <a:off x="0" y="11643778"/>
            <a:ext cx="6886297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nl-NL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nl-NL" sz="10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000" b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ree</a:t>
            </a:r>
            <a:r>
              <a:rPr lang="nl-NL" sz="10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</a:t>
            </a:r>
            <a:r>
              <a:rPr lang="nl-NL" sz="1000" b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nl-NL" sz="10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000" b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covery</a:t>
            </a:r>
            <a:r>
              <a:rPr lang="nl-NL" sz="10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nl-NL" sz="1000" b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lication</a:t>
            </a:r>
            <a:r>
              <a:rPr lang="nl-NL" sz="10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mples PCA. </a:t>
            </a:r>
            <a:r>
              <a:rPr lang="nl-NL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</a:t>
            </a:r>
            <a:r>
              <a:rPr lang="nl-NL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arson </a:t>
            </a:r>
            <a:r>
              <a:rPr lang="nl-NL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lations</a:t>
            </a:r>
            <a:r>
              <a:rPr lang="nl-NL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nl-NL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adings</a:t>
            </a:r>
            <a:r>
              <a:rPr lang="nl-NL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nl-NL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covery</a:t>
            </a:r>
            <a:r>
              <a:rPr lang="nl-NL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nl-NL" sz="1000">
                <a:latin typeface="Times New Roman" panose="02020603050405020304" pitchFamily="18" charset="0"/>
                <a:cs typeface="Times New Roman" panose="02020603050405020304" pitchFamily="18" charset="0"/>
              </a:rPr>
              <a:t>validation </a:t>
            </a:r>
            <a:r>
              <a:rPr lang="nl-NL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A.</a:t>
            </a:r>
            <a:r>
              <a:rPr lang="nl-NL" sz="10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nl-NL" sz="10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000" b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ificance</a:t>
            </a:r>
            <a:r>
              <a:rPr lang="nl-NL" sz="10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effect </a:t>
            </a:r>
            <a:r>
              <a:rPr lang="nl-NL" sz="1000" b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zes</a:t>
            </a:r>
            <a:r>
              <a:rPr lang="nl-NL" sz="10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nl-NL" sz="1000" b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ired</a:t>
            </a:r>
            <a:r>
              <a:rPr lang="nl-NL" sz="10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-tests of PC scores </a:t>
            </a:r>
            <a:r>
              <a:rPr lang="nl-NL" sz="1000" b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nl-NL" sz="10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seline and 6-year follow-up. </a:t>
            </a:r>
            <a:r>
              <a:rPr lang="nl-NL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nl-NL" sz="10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000" b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pset</a:t>
            </a:r>
            <a:r>
              <a:rPr lang="nl-NL" sz="10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of significant </a:t>
            </a:r>
            <a:r>
              <a:rPr lang="nl-NL" sz="1000" b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bolite</a:t>
            </a:r>
            <a:r>
              <a:rPr lang="nl-NL" sz="10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000" b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adings</a:t>
            </a:r>
            <a:r>
              <a:rPr lang="nl-NL" sz="10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 PC (overlapping and </a:t>
            </a:r>
            <a:r>
              <a:rPr lang="nl-NL" sz="1000" b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ique</a:t>
            </a:r>
            <a:r>
              <a:rPr lang="nl-NL" sz="10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000" b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bolites</a:t>
            </a:r>
            <a:r>
              <a:rPr lang="nl-NL" sz="10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nl-NL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0834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hthoek 5">
            <a:extLst>
              <a:ext uri="{FF2B5EF4-FFF2-40B4-BE49-F238E27FC236}">
                <a16:creationId xmlns:a16="http://schemas.microsoft.com/office/drawing/2014/main" id="{CB114B40-B471-F005-579A-F3965887DF45}"/>
              </a:ext>
            </a:extLst>
          </p:cNvPr>
          <p:cNvSpPr/>
          <p:nvPr/>
        </p:nvSpPr>
        <p:spPr>
          <a:xfrm>
            <a:off x="1021871" y="3457004"/>
            <a:ext cx="175922" cy="1568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 dirty="0"/>
          </a:p>
        </p:txBody>
      </p:sp>
      <p:sp>
        <p:nvSpPr>
          <p:cNvPr id="7" name="Tekstvak 6">
            <a:extLst>
              <a:ext uri="{FF2B5EF4-FFF2-40B4-BE49-F238E27FC236}">
                <a16:creationId xmlns:a16="http://schemas.microsoft.com/office/drawing/2014/main" id="{C8580730-0CED-027C-A428-1A094367099E}"/>
              </a:ext>
            </a:extLst>
          </p:cNvPr>
          <p:cNvSpPr txBox="1"/>
          <p:nvPr/>
        </p:nvSpPr>
        <p:spPr>
          <a:xfrm>
            <a:off x="469976" y="53973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kstvak 7">
            <a:extLst>
              <a:ext uri="{FF2B5EF4-FFF2-40B4-BE49-F238E27FC236}">
                <a16:creationId xmlns:a16="http://schemas.microsoft.com/office/drawing/2014/main" id="{5C032D24-1E7B-534E-22CD-251AE936E4CC}"/>
              </a:ext>
            </a:extLst>
          </p:cNvPr>
          <p:cNvSpPr txBox="1"/>
          <p:nvPr/>
        </p:nvSpPr>
        <p:spPr>
          <a:xfrm>
            <a:off x="457152" y="566958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Vrije vorm: vorm 3">
            <a:extLst>
              <a:ext uri="{FF2B5EF4-FFF2-40B4-BE49-F238E27FC236}">
                <a16:creationId xmlns:a16="http://schemas.microsoft.com/office/drawing/2014/main" id="{A9A56A75-3E87-CE35-9847-850BCF567529}"/>
              </a:ext>
            </a:extLst>
          </p:cNvPr>
          <p:cNvSpPr/>
          <p:nvPr/>
        </p:nvSpPr>
        <p:spPr>
          <a:xfrm>
            <a:off x="1021870" y="5669580"/>
            <a:ext cx="5056357" cy="4883361"/>
          </a:xfrm>
          <a:custGeom>
            <a:avLst/>
            <a:gdLst>
              <a:gd name="connsiteX0" fmla="*/ 0 w 5056357"/>
              <a:gd name="connsiteY0" fmla="*/ 0 h 4883361"/>
              <a:gd name="connsiteX1" fmla="*/ 5056357 w 5056357"/>
              <a:gd name="connsiteY1" fmla="*/ 0 h 4883361"/>
              <a:gd name="connsiteX2" fmla="*/ 5056357 w 5056357"/>
              <a:gd name="connsiteY2" fmla="*/ 4883361 h 4883361"/>
              <a:gd name="connsiteX3" fmla="*/ 0 w 5056357"/>
              <a:gd name="connsiteY3" fmla="*/ 4883361 h 48833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5056357" h="4883361">
                <a:moveTo>
                  <a:pt x="0" y="0"/>
                </a:moveTo>
                <a:lnTo>
                  <a:pt x="5056357" y="0"/>
                </a:lnTo>
                <a:lnTo>
                  <a:pt x="5056357" y="4883361"/>
                </a:lnTo>
                <a:lnTo>
                  <a:pt x="0" y="4883361"/>
                </a:lnTo>
                <a:close/>
              </a:path>
            </a:pathLst>
          </a:custGeom>
          <a:solidFill>
            <a:srgbClr val="FFFFFF"/>
          </a:solidFill>
          <a:ln w="8303" cap="rnd">
            <a:noFill/>
            <a:prstDash val="solid"/>
            <a:round/>
          </a:ln>
        </p:spPr>
        <p:txBody>
          <a:bodyPr rtlCol="0" anchor="ctr"/>
          <a:lstStyle/>
          <a:p>
            <a:endParaRPr lang="nl-NL"/>
          </a:p>
        </p:txBody>
      </p:sp>
      <p:grpSp>
        <p:nvGrpSpPr>
          <p:cNvPr id="5" name="Graphic 10">
            <a:extLst>
              <a:ext uri="{FF2B5EF4-FFF2-40B4-BE49-F238E27FC236}">
                <a16:creationId xmlns:a16="http://schemas.microsoft.com/office/drawing/2014/main" id="{D4C6A75E-F12B-F161-3140-24E9524C4ACC}"/>
              </a:ext>
            </a:extLst>
          </p:cNvPr>
          <p:cNvGrpSpPr/>
          <p:nvPr/>
        </p:nvGrpSpPr>
        <p:grpSpPr>
          <a:xfrm>
            <a:off x="1388871" y="7081844"/>
            <a:ext cx="3833683" cy="2767935"/>
            <a:chOff x="1388871" y="7081844"/>
            <a:chExt cx="3833683" cy="2767935"/>
          </a:xfrm>
        </p:grpSpPr>
        <p:sp>
          <p:nvSpPr>
            <p:cNvPr id="9" name="Vrije vorm: vorm 8">
              <a:extLst>
                <a:ext uri="{FF2B5EF4-FFF2-40B4-BE49-F238E27FC236}">
                  <a16:creationId xmlns:a16="http://schemas.microsoft.com/office/drawing/2014/main" id="{FD5AD3DD-2B21-EFE9-BE73-BDDAD930A979}"/>
                </a:ext>
              </a:extLst>
            </p:cNvPr>
            <p:cNvSpPr/>
            <p:nvPr/>
          </p:nvSpPr>
          <p:spPr>
            <a:xfrm>
              <a:off x="1388871" y="7567352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0" name="Vrije vorm: vorm 9">
              <a:extLst>
                <a:ext uri="{FF2B5EF4-FFF2-40B4-BE49-F238E27FC236}">
                  <a16:creationId xmlns:a16="http://schemas.microsoft.com/office/drawing/2014/main" id="{BBDA5A6A-7109-EDCC-28F9-F6ED2373604C}"/>
                </a:ext>
              </a:extLst>
            </p:cNvPr>
            <p:cNvSpPr/>
            <p:nvPr/>
          </p:nvSpPr>
          <p:spPr>
            <a:xfrm>
              <a:off x="1388871" y="8052776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2" name="Vrije vorm: vorm 11">
              <a:extLst>
                <a:ext uri="{FF2B5EF4-FFF2-40B4-BE49-F238E27FC236}">
                  <a16:creationId xmlns:a16="http://schemas.microsoft.com/office/drawing/2014/main" id="{7031380A-64F8-6B7F-6199-740BF2B7BCB3}"/>
                </a:ext>
              </a:extLst>
            </p:cNvPr>
            <p:cNvSpPr/>
            <p:nvPr/>
          </p:nvSpPr>
          <p:spPr>
            <a:xfrm>
              <a:off x="1388871" y="7081844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4 h 436923"/>
                <a:gd name="connsiteX3" fmla="*/ 0 w 436776"/>
                <a:gd name="connsiteY3" fmla="*/ 436924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4"/>
                  </a:lnTo>
                  <a:lnTo>
                    <a:pt x="0" y="436924"/>
                  </a:lnTo>
                  <a:close/>
                </a:path>
              </a:pathLst>
            </a:custGeom>
            <a:solidFill>
              <a:srgbClr val="3B3B3B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3" name="Vrije vorm: vorm 12">
              <a:extLst>
                <a:ext uri="{FF2B5EF4-FFF2-40B4-BE49-F238E27FC236}">
                  <a16:creationId xmlns:a16="http://schemas.microsoft.com/office/drawing/2014/main" id="{1DFE8052-D552-E4C4-AA5D-84094766AEA1}"/>
                </a:ext>
              </a:extLst>
            </p:cNvPr>
            <p:cNvSpPr/>
            <p:nvPr/>
          </p:nvSpPr>
          <p:spPr>
            <a:xfrm>
              <a:off x="3815257" y="7567352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4" name="Vrije vorm: vorm 13">
              <a:extLst>
                <a:ext uri="{FF2B5EF4-FFF2-40B4-BE49-F238E27FC236}">
                  <a16:creationId xmlns:a16="http://schemas.microsoft.com/office/drawing/2014/main" id="{1EAD0A18-5254-0AD0-6F06-0CECD69F9D6C}"/>
                </a:ext>
              </a:extLst>
            </p:cNvPr>
            <p:cNvSpPr/>
            <p:nvPr/>
          </p:nvSpPr>
          <p:spPr>
            <a:xfrm>
              <a:off x="3815257" y="8052776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5" name="Vrije vorm: vorm 14">
              <a:extLst>
                <a:ext uri="{FF2B5EF4-FFF2-40B4-BE49-F238E27FC236}">
                  <a16:creationId xmlns:a16="http://schemas.microsoft.com/office/drawing/2014/main" id="{F21917CC-7BD4-A7FB-FA14-8180077E02DB}"/>
                </a:ext>
              </a:extLst>
            </p:cNvPr>
            <p:cNvSpPr/>
            <p:nvPr/>
          </p:nvSpPr>
          <p:spPr>
            <a:xfrm>
              <a:off x="3815257" y="7081844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4 h 436923"/>
                <a:gd name="connsiteX3" fmla="*/ 0 w 436776"/>
                <a:gd name="connsiteY3" fmla="*/ 436924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4"/>
                  </a:lnTo>
                  <a:lnTo>
                    <a:pt x="0" y="436924"/>
                  </a:lnTo>
                  <a:close/>
                </a:path>
              </a:pathLst>
            </a:custGeom>
            <a:solidFill>
              <a:srgbClr val="3B3B3B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6" name="Vrije vorm: vorm 15">
              <a:extLst>
                <a:ext uri="{FF2B5EF4-FFF2-40B4-BE49-F238E27FC236}">
                  <a16:creationId xmlns:a16="http://schemas.microsoft.com/office/drawing/2014/main" id="{A1E99C62-EECA-27A9-5F50-71EAC24C9D4B}"/>
                </a:ext>
              </a:extLst>
            </p:cNvPr>
            <p:cNvSpPr/>
            <p:nvPr/>
          </p:nvSpPr>
          <p:spPr>
            <a:xfrm>
              <a:off x="3329997" y="7567352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7" name="Vrije vorm: vorm 16">
              <a:extLst>
                <a:ext uri="{FF2B5EF4-FFF2-40B4-BE49-F238E27FC236}">
                  <a16:creationId xmlns:a16="http://schemas.microsoft.com/office/drawing/2014/main" id="{4AB007A5-9B3C-80B7-90A2-628DC87A5865}"/>
                </a:ext>
              </a:extLst>
            </p:cNvPr>
            <p:cNvSpPr/>
            <p:nvPr/>
          </p:nvSpPr>
          <p:spPr>
            <a:xfrm>
              <a:off x="3329997" y="8052776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3B3B3B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8" name="Vrije vorm: vorm 17">
              <a:extLst>
                <a:ext uri="{FF2B5EF4-FFF2-40B4-BE49-F238E27FC236}">
                  <a16:creationId xmlns:a16="http://schemas.microsoft.com/office/drawing/2014/main" id="{65A6CA52-4B58-80BF-9B22-3CF1A859636A}"/>
                </a:ext>
              </a:extLst>
            </p:cNvPr>
            <p:cNvSpPr/>
            <p:nvPr/>
          </p:nvSpPr>
          <p:spPr>
            <a:xfrm>
              <a:off x="3329997" y="7081844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4 h 436923"/>
                <a:gd name="connsiteX3" fmla="*/ 0 w 436776"/>
                <a:gd name="connsiteY3" fmla="*/ 436924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4"/>
                  </a:lnTo>
                  <a:lnTo>
                    <a:pt x="0" y="436924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19" name="Vrije vorm: vorm 18">
              <a:extLst>
                <a:ext uri="{FF2B5EF4-FFF2-40B4-BE49-F238E27FC236}">
                  <a16:creationId xmlns:a16="http://schemas.microsoft.com/office/drawing/2014/main" id="{76D686C2-BBF7-2184-DB30-C23AB7C5F5A2}"/>
                </a:ext>
              </a:extLst>
            </p:cNvPr>
            <p:cNvSpPr/>
            <p:nvPr/>
          </p:nvSpPr>
          <p:spPr>
            <a:xfrm>
              <a:off x="1874132" y="7567352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0" name="Vrije vorm: vorm 19">
              <a:extLst>
                <a:ext uri="{FF2B5EF4-FFF2-40B4-BE49-F238E27FC236}">
                  <a16:creationId xmlns:a16="http://schemas.microsoft.com/office/drawing/2014/main" id="{29F50D01-8BED-DA7C-7338-161CC779B242}"/>
                </a:ext>
              </a:extLst>
            </p:cNvPr>
            <p:cNvSpPr/>
            <p:nvPr/>
          </p:nvSpPr>
          <p:spPr>
            <a:xfrm>
              <a:off x="1874132" y="8052776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1" name="Vrije vorm: vorm 20">
              <a:extLst>
                <a:ext uri="{FF2B5EF4-FFF2-40B4-BE49-F238E27FC236}">
                  <a16:creationId xmlns:a16="http://schemas.microsoft.com/office/drawing/2014/main" id="{F06BCA9E-8763-3BF3-FDBF-EA2EDBB54472}"/>
                </a:ext>
              </a:extLst>
            </p:cNvPr>
            <p:cNvSpPr/>
            <p:nvPr/>
          </p:nvSpPr>
          <p:spPr>
            <a:xfrm>
              <a:off x="1874132" y="7081844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4 h 436923"/>
                <a:gd name="connsiteX3" fmla="*/ 0 w 436776"/>
                <a:gd name="connsiteY3" fmla="*/ 436924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4"/>
                  </a:lnTo>
                  <a:lnTo>
                    <a:pt x="0" y="436924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2" name="Vrije vorm: vorm 21">
              <a:extLst>
                <a:ext uri="{FF2B5EF4-FFF2-40B4-BE49-F238E27FC236}">
                  <a16:creationId xmlns:a16="http://schemas.microsoft.com/office/drawing/2014/main" id="{79AF24BF-4D26-6083-5112-EEC1AD5F3CFC}"/>
                </a:ext>
              </a:extLst>
            </p:cNvPr>
            <p:cNvSpPr/>
            <p:nvPr/>
          </p:nvSpPr>
          <p:spPr>
            <a:xfrm>
              <a:off x="2844736" y="7567352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3" name="Vrije vorm: vorm 22">
              <a:extLst>
                <a:ext uri="{FF2B5EF4-FFF2-40B4-BE49-F238E27FC236}">
                  <a16:creationId xmlns:a16="http://schemas.microsoft.com/office/drawing/2014/main" id="{991A480C-6F52-30A9-838C-E27680ACD221}"/>
                </a:ext>
              </a:extLst>
            </p:cNvPr>
            <p:cNvSpPr/>
            <p:nvPr/>
          </p:nvSpPr>
          <p:spPr>
            <a:xfrm>
              <a:off x="2844736" y="8052776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4" name="Vrije vorm: vorm 23">
              <a:extLst>
                <a:ext uri="{FF2B5EF4-FFF2-40B4-BE49-F238E27FC236}">
                  <a16:creationId xmlns:a16="http://schemas.microsoft.com/office/drawing/2014/main" id="{ABF4BE7F-A482-A24C-5943-E781D605D51F}"/>
                </a:ext>
              </a:extLst>
            </p:cNvPr>
            <p:cNvSpPr/>
            <p:nvPr/>
          </p:nvSpPr>
          <p:spPr>
            <a:xfrm>
              <a:off x="2844736" y="7081844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4 h 436923"/>
                <a:gd name="connsiteX3" fmla="*/ 0 w 436776"/>
                <a:gd name="connsiteY3" fmla="*/ 436924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4"/>
                  </a:lnTo>
                  <a:lnTo>
                    <a:pt x="0" y="436924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5" name="Vrije vorm: vorm 24">
              <a:extLst>
                <a:ext uri="{FF2B5EF4-FFF2-40B4-BE49-F238E27FC236}">
                  <a16:creationId xmlns:a16="http://schemas.microsoft.com/office/drawing/2014/main" id="{D2BA187C-0D06-F570-CFA5-66B9C36E708C}"/>
                </a:ext>
              </a:extLst>
            </p:cNvPr>
            <p:cNvSpPr/>
            <p:nvPr/>
          </p:nvSpPr>
          <p:spPr>
            <a:xfrm>
              <a:off x="4785778" y="7567352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6" name="Vrije vorm: vorm 25">
              <a:extLst>
                <a:ext uri="{FF2B5EF4-FFF2-40B4-BE49-F238E27FC236}">
                  <a16:creationId xmlns:a16="http://schemas.microsoft.com/office/drawing/2014/main" id="{3FFA8EF1-4FDD-6254-1698-991E09425746}"/>
                </a:ext>
              </a:extLst>
            </p:cNvPr>
            <p:cNvSpPr/>
            <p:nvPr/>
          </p:nvSpPr>
          <p:spPr>
            <a:xfrm>
              <a:off x="4785778" y="8052776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7" name="Vrije vorm: vorm 26">
              <a:extLst>
                <a:ext uri="{FF2B5EF4-FFF2-40B4-BE49-F238E27FC236}">
                  <a16:creationId xmlns:a16="http://schemas.microsoft.com/office/drawing/2014/main" id="{B7B73D50-3136-29DC-9272-7664BBCBFB12}"/>
                </a:ext>
              </a:extLst>
            </p:cNvPr>
            <p:cNvSpPr/>
            <p:nvPr/>
          </p:nvSpPr>
          <p:spPr>
            <a:xfrm>
              <a:off x="4785778" y="7081844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4 h 436923"/>
                <a:gd name="connsiteX3" fmla="*/ 0 w 436776"/>
                <a:gd name="connsiteY3" fmla="*/ 436924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4"/>
                  </a:lnTo>
                  <a:lnTo>
                    <a:pt x="0" y="436924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8" name="Vrije vorm: vorm 27">
              <a:extLst>
                <a:ext uri="{FF2B5EF4-FFF2-40B4-BE49-F238E27FC236}">
                  <a16:creationId xmlns:a16="http://schemas.microsoft.com/office/drawing/2014/main" id="{750A0B81-6ADB-83C5-6662-4E3FB01981EA}"/>
                </a:ext>
              </a:extLst>
            </p:cNvPr>
            <p:cNvSpPr/>
            <p:nvPr/>
          </p:nvSpPr>
          <p:spPr>
            <a:xfrm>
              <a:off x="2359476" y="7567352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29" name="Vrije vorm: vorm 28">
              <a:extLst>
                <a:ext uri="{FF2B5EF4-FFF2-40B4-BE49-F238E27FC236}">
                  <a16:creationId xmlns:a16="http://schemas.microsoft.com/office/drawing/2014/main" id="{41311D57-94BE-83A3-A970-AA34CA811D61}"/>
                </a:ext>
              </a:extLst>
            </p:cNvPr>
            <p:cNvSpPr/>
            <p:nvPr/>
          </p:nvSpPr>
          <p:spPr>
            <a:xfrm>
              <a:off x="2359476" y="8052776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0" name="Vrije vorm: vorm 29">
              <a:extLst>
                <a:ext uri="{FF2B5EF4-FFF2-40B4-BE49-F238E27FC236}">
                  <a16:creationId xmlns:a16="http://schemas.microsoft.com/office/drawing/2014/main" id="{63DF0591-8185-44D5-116A-D62842D668F7}"/>
                </a:ext>
              </a:extLst>
            </p:cNvPr>
            <p:cNvSpPr/>
            <p:nvPr/>
          </p:nvSpPr>
          <p:spPr>
            <a:xfrm>
              <a:off x="2359476" y="7081844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4 h 436923"/>
                <a:gd name="connsiteX3" fmla="*/ 0 w 436776"/>
                <a:gd name="connsiteY3" fmla="*/ 436924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4"/>
                  </a:lnTo>
                  <a:lnTo>
                    <a:pt x="0" y="436924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1" name="Vrije vorm: vorm 30">
              <a:extLst>
                <a:ext uri="{FF2B5EF4-FFF2-40B4-BE49-F238E27FC236}">
                  <a16:creationId xmlns:a16="http://schemas.microsoft.com/office/drawing/2014/main" id="{CBE6344D-352C-FDCF-4D3D-B6D623E22747}"/>
                </a:ext>
              </a:extLst>
            </p:cNvPr>
            <p:cNvSpPr/>
            <p:nvPr/>
          </p:nvSpPr>
          <p:spPr>
            <a:xfrm>
              <a:off x="4300518" y="7567352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2" name="Vrije vorm: vorm 31">
              <a:extLst>
                <a:ext uri="{FF2B5EF4-FFF2-40B4-BE49-F238E27FC236}">
                  <a16:creationId xmlns:a16="http://schemas.microsoft.com/office/drawing/2014/main" id="{1927ABDE-E019-ED36-24FC-DABB17601004}"/>
                </a:ext>
              </a:extLst>
            </p:cNvPr>
            <p:cNvSpPr/>
            <p:nvPr/>
          </p:nvSpPr>
          <p:spPr>
            <a:xfrm>
              <a:off x="4300518" y="8052776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3 h 436923"/>
                <a:gd name="connsiteX3" fmla="*/ 0 w 436776"/>
                <a:gd name="connsiteY3" fmla="*/ 436923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3"/>
                  </a:lnTo>
                  <a:lnTo>
                    <a:pt x="0" y="436923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33" name="Vrije vorm: vorm 32">
              <a:extLst>
                <a:ext uri="{FF2B5EF4-FFF2-40B4-BE49-F238E27FC236}">
                  <a16:creationId xmlns:a16="http://schemas.microsoft.com/office/drawing/2014/main" id="{284BE27A-5462-AC86-BA52-D426819DCD0E}"/>
                </a:ext>
              </a:extLst>
            </p:cNvPr>
            <p:cNvSpPr/>
            <p:nvPr/>
          </p:nvSpPr>
          <p:spPr>
            <a:xfrm>
              <a:off x="4300518" y="7081844"/>
              <a:ext cx="436776" cy="436923"/>
            </a:xfrm>
            <a:custGeom>
              <a:avLst/>
              <a:gdLst>
                <a:gd name="connsiteX0" fmla="*/ 0 w 436776"/>
                <a:gd name="connsiteY0" fmla="*/ 0 h 436923"/>
                <a:gd name="connsiteX1" fmla="*/ 436776 w 436776"/>
                <a:gd name="connsiteY1" fmla="*/ 0 h 436923"/>
                <a:gd name="connsiteX2" fmla="*/ 436776 w 436776"/>
                <a:gd name="connsiteY2" fmla="*/ 436924 h 436923"/>
                <a:gd name="connsiteX3" fmla="*/ 0 w 436776"/>
                <a:gd name="connsiteY3" fmla="*/ 436924 h 4369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36776" h="436923">
                  <a:moveTo>
                    <a:pt x="0" y="0"/>
                  </a:moveTo>
                  <a:lnTo>
                    <a:pt x="436776" y="0"/>
                  </a:lnTo>
                  <a:lnTo>
                    <a:pt x="436776" y="436924"/>
                  </a:lnTo>
                  <a:lnTo>
                    <a:pt x="0" y="436924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</p:grpSp>
      <p:grpSp>
        <p:nvGrpSpPr>
          <p:cNvPr id="34" name="Graphic 10">
            <a:extLst>
              <a:ext uri="{FF2B5EF4-FFF2-40B4-BE49-F238E27FC236}">
                <a16:creationId xmlns:a16="http://schemas.microsoft.com/office/drawing/2014/main" id="{639FE967-F969-3F13-BF55-3C5B9458BD62}"/>
              </a:ext>
            </a:extLst>
          </p:cNvPr>
          <p:cNvGrpSpPr/>
          <p:nvPr/>
        </p:nvGrpSpPr>
        <p:grpSpPr>
          <a:xfrm>
            <a:off x="975754" y="7205836"/>
            <a:ext cx="5054589" cy="1803781"/>
            <a:chOff x="975754" y="7205836"/>
            <a:chExt cx="5054589" cy="1803781"/>
          </a:xfrm>
        </p:grpSpPr>
        <p:sp>
          <p:nvSpPr>
            <p:cNvPr id="35" name="Tekstvak 34">
              <a:extLst>
                <a:ext uri="{FF2B5EF4-FFF2-40B4-BE49-F238E27FC236}">
                  <a16:creationId xmlns:a16="http://schemas.microsoft.com/office/drawing/2014/main" id="{2E08FE65-A0D9-2BC7-F6BE-AF7239C8784C}"/>
                </a:ext>
              </a:extLst>
            </p:cNvPr>
            <p:cNvSpPr txBox="1"/>
            <p:nvPr/>
          </p:nvSpPr>
          <p:spPr>
            <a:xfrm>
              <a:off x="1009019" y="8176684"/>
              <a:ext cx="357523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>
                  <a:ln/>
                  <a:solidFill>
                    <a:srgbClr val="4D4D4D"/>
                  </a:solidFill>
                  <a:latin typeface="Arial"/>
                  <a:cs typeface="Arial"/>
                  <a:sym typeface="Arial"/>
                  <a:rtl val="0"/>
                </a:rPr>
                <a:t>down</a:t>
              </a:r>
            </a:p>
          </p:txBody>
        </p:sp>
        <p:sp>
          <p:nvSpPr>
            <p:cNvPr id="36" name="Tekstvak 35">
              <a:extLst>
                <a:ext uri="{FF2B5EF4-FFF2-40B4-BE49-F238E27FC236}">
                  <a16:creationId xmlns:a16="http://schemas.microsoft.com/office/drawing/2014/main" id="{1CDBE67D-518F-9FDC-29D1-0724D4C226E9}"/>
                </a:ext>
              </a:extLst>
            </p:cNvPr>
            <p:cNvSpPr txBox="1"/>
            <p:nvPr/>
          </p:nvSpPr>
          <p:spPr>
            <a:xfrm>
              <a:off x="975754" y="7691260"/>
              <a:ext cx="390789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>
                  <a:ln/>
                  <a:solidFill>
                    <a:srgbClr val="4D4D4D"/>
                  </a:solidFill>
                  <a:latin typeface="Arial"/>
                  <a:cs typeface="Arial"/>
                  <a:sym typeface="Arial"/>
                  <a:rtl val="0"/>
                </a:rPr>
                <a:t>stable</a:t>
              </a:r>
            </a:p>
          </p:txBody>
        </p:sp>
        <p:sp>
          <p:nvSpPr>
            <p:cNvPr id="37" name="Tekstvak 36">
              <a:extLst>
                <a:ext uri="{FF2B5EF4-FFF2-40B4-BE49-F238E27FC236}">
                  <a16:creationId xmlns:a16="http://schemas.microsoft.com/office/drawing/2014/main" id="{D85482A1-DB26-F920-8278-8051C2875311}"/>
                </a:ext>
              </a:extLst>
            </p:cNvPr>
            <p:cNvSpPr txBox="1"/>
            <p:nvPr/>
          </p:nvSpPr>
          <p:spPr>
            <a:xfrm>
              <a:off x="1100499" y="7205836"/>
              <a:ext cx="266043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>
                  <a:ln/>
                  <a:solidFill>
                    <a:srgbClr val="4D4D4D"/>
                  </a:solidFill>
                  <a:latin typeface="Arial"/>
                  <a:cs typeface="Arial"/>
                  <a:sym typeface="Arial"/>
                  <a:rtl val="0"/>
                </a:rPr>
                <a:t>up</a:t>
              </a:r>
            </a:p>
          </p:txBody>
        </p:sp>
        <p:sp>
          <p:nvSpPr>
            <p:cNvPr id="38" name="Tekstvak 37">
              <a:extLst>
                <a:ext uri="{FF2B5EF4-FFF2-40B4-BE49-F238E27FC236}">
                  <a16:creationId xmlns:a16="http://schemas.microsoft.com/office/drawing/2014/main" id="{46118A34-4B00-7159-CE8D-DDD328B52FF5}"/>
                </a:ext>
              </a:extLst>
            </p:cNvPr>
            <p:cNvSpPr txBox="1"/>
            <p:nvPr/>
          </p:nvSpPr>
          <p:spPr>
            <a:xfrm rot="-2700000">
              <a:off x="1201474" y="8665401"/>
              <a:ext cx="573749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 dirty="0">
                  <a:ln/>
                  <a:solidFill>
                    <a:srgbClr val="4D4D4D"/>
                  </a:solidFill>
                  <a:latin typeface="Arial"/>
                  <a:cs typeface="Arial"/>
                  <a:sym typeface="Arial"/>
                  <a:rtl val="0"/>
                </a:rPr>
                <a:t>Amino Acid</a:t>
              </a:r>
            </a:p>
          </p:txBody>
        </p:sp>
        <p:sp>
          <p:nvSpPr>
            <p:cNvPr id="39" name="Tekstvak 38">
              <a:extLst>
                <a:ext uri="{FF2B5EF4-FFF2-40B4-BE49-F238E27FC236}">
                  <a16:creationId xmlns:a16="http://schemas.microsoft.com/office/drawing/2014/main" id="{CE43654A-70D0-3EC6-8107-4C79D058BC0D}"/>
                </a:ext>
              </a:extLst>
            </p:cNvPr>
            <p:cNvSpPr txBox="1"/>
            <p:nvPr/>
          </p:nvSpPr>
          <p:spPr>
            <a:xfrm rot="-2700000">
              <a:off x="1615750" y="8694813"/>
              <a:ext cx="656913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>
                  <a:ln/>
                  <a:solidFill>
                    <a:srgbClr val="4D4D4D"/>
                  </a:solidFill>
                  <a:latin typeface="Arial"/>
                  <a:cs typeface="Arial"/>
                  <a:sym typeface="Arial"/>
                  <a:rtl val="0"/>
                </a:rPr>
                <a:t>Carbohydrate</a:t>
              </a:r>
            </a:p>
          </p:txBody>
        </p:sp>
        <p:sp>
          <p:nvSpPr>
            <p:cNvPr id="40" name="Tekstvak 39">
              <a:extLst>
                <a:ext uri="{FF2B5EF4-FFF2-40B4-BE49-F238E27FC236}">
                  <a16:creationId xmlns:a16="http://schemas.microsoft.com/office/drawing/2014/main" id="{C6C8D49A-8DA5-2377-ECE4-561436A0029E}"/>
                </a:ext>
              </a:extLst>
            </p:cNvPr>
            <p:cNvSpPr txBox="1"/>
            <p:nvPr/>
          </p:nvSpPr>
          <p:spPr>
            <a:xfrm rot="-2700000">
              <a:off x="1802875" y="8818347"/>
              <a:ext cx="1006201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>
                  <a:ln/>
                  <a:solidFill>
                    <a:srgbClr val="4D4D4D"/>
                  </a:solidFill>
                  <a:latin typeface="Arial"/>
                  <a:cs typeface="Arial"/>
                  <a:sym typeface="Arial"/>
                  <a:rtl val="0"/>
                </a:rPr>
                <a:t>Cofactors and Vitamins</a:t>
              </a:r>
            </a:p>
          </p:txBody>
        </p:sp>
        <p:sp>
          <p:nvSpPr>
            <p:cNvPr id="41" name="Tekstvak 40">
              <a:extLst>
                <a:ext uri="{FF2B5EF4-FFF2-40B4-BE49-F238E27FC236}">
                  <a16:creationId xmlns:a16="http://schemas.microsoft.com/office/drawing/2014/main" id="{5D821580-9139-7A26-35E7-C4F5E460D3BD}"/>
                </a:ext>
              </a:extLst>
            </p:cNvPr>
            <p:cNvSpPr txBox="1"/>
            <p:nvPr/>
          </p:nvSpPr>
          <p:spPr>
            <a:xfrm rot="-2700000">
              <a:off x="2777930" y="8615399"/>
              <a:ext cx="432371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>
                  <a:ln/>
                  <a:solidFill>
                    <a:srgbClr val="4D4D4D"/>
                  </a:solidFill>
                  <a:latin typeface="Arial"/>
                  <a:cs typeface="Arial"/>
                  <a:sym typeface="Arial"/>
                  <a:rtl val="0"/>
                </a:rPr>
                <a:t>Energy</a:t>
              </a:r>
            </a:p>
          </p:txBody>
        </p:sp>
        <p:sp>
          <p:nvSpPr>
            <p:cNvPr id="42" name="Tekstvak 41">
              <a:extLst>
                <a:ext uri="{FF2B5EF4-FFF2-40B4-BE49-F238E27FC236}">
                  <a16:creationId xmlns:a16="http://schemas.microsoft.com/office/drawing/2014/main" id="{58D6FC59-CB07-EF0E-88BD-0BB2CF4DA5D4}"/>
                </a:ext>
              </a:extLst>
            </p:cNvPr>
            <p:cNvSpPr txBox="1"/>
            <p:nvPr/>
          </p:nvSpPr>
          <p:spPr>
            <a:xfrm rot="-2700000">
              <a:off x="3341274" y="8583045"/>
              <a:ext cx="340891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>
                  <a:ln/>
                  <a:solidFill>
                    <a:srgbClr val="4D4D4D"/>
                  </a:solidFill>
                  <a:latin typeface="Arial"/>
                  <a:cs typeface="Arial"/>
                  <a:sym typeface="Arial"/>
                  <a:rtl val="0"/>
                </a:rPr>
                <a:t>Lipid</a:t>
              </a:r>
            </a:p>
          </p:txBody>
        </p:sp>
        <p:sp>
          <p:nvSpPr>
            <p:cNvPr id="43" name="Tekstvak 42">
              <a:extLst>
                <a:ext uri="{FF2B5EF4-FFF2-40B4-BE49-F238E27FC236}">
                  <a16:creationId xmlns:a16="http://schemas.microsoft.com/office/drawing/2014/main" id="{6BC2C874-B869-3057-8F6B-E96B2AF65561}"/>
                </a:ext>
              </a:extLst>
            </p:cNvPr>
            <p:cNvSpPr txBox="1"/>
            <p:nvPr/>
          </p:nvSpPr>
          <p:spPr>
            <a:xfrm rot="-2700000">
              <a:off x="3649155" y="8656577"/>
              <a:ext cx="548800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>
                  <a:ln/>
                  <a:solidFill>
                    <a:srgbClr val="4D4D4D"/>
                  </a:solidFill>
                  <a:latin typeface="Arial"/>
                  <a:cs typeface="Arial"/>
                  <a:sym typeface="Arial"/>
                  <a:rtl val="0"/>
                </a:rPr>
                <a:t>Nucleotide</a:t>
              </a:r>
            </a:p>
          </p:txBody>
        </p:sp>
        <p:sp>
          <p:nvSpPr>
            <p:cNvPr id="44" name="Tekstvak 43">
              <a:extLst>
                <a:ext uri="{FF2B5EF4-FFF2-40B4-BE49-F238E27FC236}">
                  <a16:creationId xmlns:a16="http://schemas.microsoft.com/office/drawing/2014/main" id="{23A4CDC7-A09D-7CB6-79F5-A641E48CB16A}"/>
                </a:ext>
              </a:extLst>
            </p:cNvPr>
            <p:cNvSpPr txBox="1"/>
            <p:nvPr/>
          </p:nvSpPr>
          <p:spPr>
            <a:xfrm rot="-2700000">
              <a:off x="4226696" y="8618340"/>
              <a:ext cx="440687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>
                  <a:ln/>
                  <a:solidFill>
                    <a:srgbClr val="4D4D4D"/>
                  </a:solidFill>
                  <a:latin typeface="Arial"/>
                  <a:cs typeface="Arial"/>
                  <a:sym typeface="Arial"/>
                  <a:rtl val="0"/>
                </a:rPr>
                <a:t>Peptide</a:t>
              </a:r>
            </a:p>
          </p:txBody>
        </p:sp>
        <p:sp>
          <p:nvSpPr>
            <p:cNvPr id="45" name="Tekstvak 44">
              <a:extLst>
                <a:ext uri="{FF2B5EF4-FFF2-40B4-BE49-F238E27FC236}">
                  <a16:creationId xmlns:a16="http://schemas.microsoft.com/office/drawing/2014/main" id="{BD61D36E-E060-FEFF-9C5F-59238C2058DF}"/>
                </a:ext>
              </a:extLst>
            </p:cNvPr>
            <p:cNvSpPr txBox="1"/>
            <p:nvPr/>
          </p:nvSpPr>
          <p:spPr>
            <a:xfrm rot="-2700000">
              <a:off x="4598381" y="8665401"/>
              <a:ext cx="573749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>
                  <a:ln/>
                  <a:solidFill>
                    <a:srgbClr val="4D4D4D"/>
                  </a:solidFill>
                  <a:latin typeface="Arial"/>
                  <a:cs typeface="Arial"/>
                  <a:sym typeface="Arial"/>
                  <a:rtl val="0"/>
                </a:rPr>
                <a:t>Xenobiotics</a:t>
              </a:r>
            </a:p>
          </p:txBody>
        </p:sp>
        <p:sp>
          <p:nvSpPr>
            <p:cNvPr id="46" name="Vrije vorm: vorm 45">
              <a:extLst>
                <a:ext uri="{FF2B5EF4-FFF2-40B4-BE49-F238E27FC236}">
                  <a16:creationId xmlns:a16="http://schemas.microsoft.com/office/drawing/2014/main" id="{B7C6E61C-E8B8-D221-4CEC-2931D3B222AB}"/>
                </a:ext>
              </a:extLst>
            </p:cNvPr>
            <p:cNvSpPr/>
            <p:nvPr/>
          </p:nvSpPr>
          <p:spPr>
            <a:xfrm>
              <a:off x="5449675" y="7726165"/>
              <a:ext cx="108362" cy="108398"/>
            </a:xfrm>
            <a:custGeom>
              <a:avLst/>
              <a:gdLst>
                <a:gd name="connsiteX0" fmla="*/ 0 w 108362"/>
                <a:gd name="connsiteY0" fmla="*/ 0 h 108398"/>
                <a:gd name="connsiteX1" fmla="*/ 108362 w 108362"/>
                <a:gd name="connsiteY1" fmla="*/ 0 h 108398"/>
                <a:gd name="connsiteX2" fmla="*/ 108362 w 108362"/>
                <a:gd name="connsiteY2" fmla="*/ 108399 h 108398"/>
                <a:gd name="connsiteX3" fmla="*/ 0 w 108362"/>
                <a:gd name="connsiteY3" fmla="*/ 108399 h 10839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8362" h="108398">
                  <a:moveTo>
                    <a:pt x="0" y="0"/>
                  </a:moveTo>
                  <a:lnTo>
                    <a:pt x="108362" y="0"/>
                  </a:lnTo>
                  <a:lnTo>
                    <a:pt x="108362" y="108399"/>
                  </a:lnTo>
                  <a:lnTo>
                    <a:pt x="0" y="108399"/>
                  </a:lnTo>
                  <a:close/>
                </a:path>
              </a:pathLst>
            </a:custGeom>
            <a:solidFill>
              <a:srgbClr val="EBEDF0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7" name="Vrije vorm: vorm 46">
              <a:extLst>
                <a:ext uri="{FF2B5EF4-FFF2-40B4-BE49-F238E27FC236}">
                  <a16:creationId xmlns:a16="http://schemas.microsoft.com/office/drawing/2014/main" id="{7007C814-CA12-3F3A-9B6A-F18368A646CF}"/>
                </a:ext>
              </a:extLst>
            </p:cNvPr>
            <p:cNvSpPr/>
            <p:nvPr/>
          </p:nvSpPr>
          <p:spPr>
            <a:xfrm>
              <a:off x="5449675" y="7869921"/>
              <a:ext cx="108362" cy="108398"/>
            </a:xfrm>
            <a:custGeom>
              <a:avLst/>
              <a:gdLst>
                <a:gd name="connsiteX0" fmla="*/ 0 w 108362"/>
                <a:gd name="connsiteY0" fmla="*/ 0 h 108398"/>
                <a:gd name="connsiteX1" fmla="*/ 108362 w 108362"/>
                <a:gd name="connsiteY1" fmla="*/ 0 h 108398"/>
                <a:gd name="connsiteX2" fmla="*/ 108362 w 108362"/>
                <a:gd name="connsiteY2" fmla="*/ 108399 h 108398"/>
                <a:gd name="connsiteX3" fmla="*/ 0 w 108362"/>
                <a:gd name="connsiteY3" fmla="*/ 108399 h 10839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8362" h="108398">
                  <a:moveTo>
                    <a:pt x="0" y="0"/>
                  </a:moveTo>
                  <a:lnTo>
                    <a:pt x="108362" y="0"/>
                  </a:lnTo>
                  <a:lnTo>
                    <a:pt x="108362" y="108399"/>
                  </a:lnTo>
                  <a:lnTo>
                    <a:pt x="0" y="108399"/>
                  </a:lnTo>
                  <a:close/>
                </a:path>
              </a:pathLst>
            </a:custGeom>
            <a:solidFill>
              <a:srgbClr val="3B3B3B"/>
            </a:solidFill>
            <a:ln w="2657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nl-NL"/>
            </a:p>
          </p:txBody>
        </p:sp>
        <p:sp>
          <p:nvSpPr>
            <p:cNvPr id="48" name="Tekstvak 47">
              <a:extLst>
                <a:ext uri="{FF2B5EF4-FFF2-40B4-BE49-F238E27FC236}">
                  <a16:creationId xmlns:a16="http://schemas.microsoft.com/office/drawing/2014/main" id="{3000921E-6F58-B11A-E6B6-73014426E44A}"/>
                </a:ext>
              </a:extLst>
            </p:cNvPr>
            <p:cNvSpPr txBox="1"/>
            <p:nvPr/>
          </p:nvSpPr>
          <p:spPr>
            <a:xfrm>
              <a:off x="5529885" y="7685853"/>
              <a:ext cx="266043" cy="1912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spc="0" baseline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ns</a:t>
              </a:r>
            </a:p>
          </p:txBody>
        </p:sp>
        <p:sp>
          <p:nvSpPr>
            <p:cNvPr id="49" name="Tekstvak 48">
              <a:extLst>
                <a:ext uri="{FF2B5EF4-FFF2-40B4-BE49-F238E27FC236}">
                  <a16:creationId xmlns:a16="http://schemas.microsoft.com/office/drawing/2014/main" id="{EEB721AA-2BF1-A4B9-0215-A02706C03E9D}"/>
                </a:ext>
              </a:extLst>
            </p:cNvPr>
            <p:cNvSpPr txBox="1"/>
            <p:nvPr/>
          </p:nvSpPr>
          <p:spPr>
            <a:xfrm>
              <a:off x="5529885" y="7829608"/>
              <a:ext cx="500458" cy="1962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nl-NL" sz="675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p</a:t>
              </a:r>
              <a:r>
                <a:rPr lang="nl-NL" sz="675" spc="0" baseline="0" dirty="0">
                  <a:ln/>
                  <a:solidFill>
                    <a:srgbClr val="000000"/>
                  </a:solidFill>
                  <a:latin typeface="Arial"/>
                  <a:cs typeface="Arial"/>
                  <a:sym typeface="Arial"/>
                  <a:rtl val="0"/>
                </a:rPr>
                <a:t>&lt;0.001</a:t>
              </a:r>
            </a:p>
          </p:txBody>
        </p:sp>
      </p:grpSp>
      <p:sp>
        <p:nvSpPr>
          <p:cNvPr id="2" name="Tekstvak 1">
            <a:extLst>
              <a:ext uri="{FF2B5EF4-FFF2-40B4-BE49-F238E27FC236}">
                <a16:creationId xmlns:a16="http://schemas.microsoft.com/office/drawing/2014/main" id="{B960526B-C908-E601-400E-397A472156C9}"/>
              </a:ext>
            </a:extLst>
          </p:cNvPr>
          <p:cNvSpPr txBox="1"/>
          <p:nvPr/>
        </p:nvSpPr>
        <p:spPr>
          <a:xfrm>
            <a:off x="-28297" y="4890"/>
            <a:ext cx="10470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</a:t>
            </a:r>
            <a:r>
              <a:rPr lang="nl-NL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nl-NL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</a:t>
            </a:r>
          </a:p>
        </p:txBody>
      </p:sp>
      <p:pic>
        <p:nvPicPr>
          <p:cNvPr id="11" name="Graphic 10">
            <a:extLst>
              <a:ext uri="{FF2B5EF4-FFF2-40B4-BE49-F238E27FC236}">
                <a16:creationId xmlns:a16="http://schemas.microsoft.com/office/drawing/2014/main" id="{07EE9C2F-996B-1B02-CD98-9CFC6010F0F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052604" y="650611"/>
            <a:ext cx="4918230" cy="5016142"/>
          </a:xfrm>
          <a:prstGeom prst="rect">
            <a:avLst/>
          </a:prstGeom>
        </p:spPr>
      </p:pic>
      <p:sp>
        <p:nvSpPr>
          <p:cNvPr id="50" name="Tekstvak 49">
            <a:extLst>
              <a:ext uri="{FF2B5EF4-FFF2-40B4-BE49-F238E27FC236}">
                <a16:creationId xmlns:a16="http://schemas.microsoft.com/office/drawing/2014/main" id="{7D6A40FA-DB39-1007-EF35-72C9CFB57359}"/>
              </a:ext>
            </a:extLst>
          </p:cNvPr>
          <p:cNvSpPr txBox="1"/>
          <p:nvPr/>
        </p:nvSpPr>
        <p:spPr>
          <a:xfrm>
            <a:off x="0" y="9517797"/>
            <a:ext cx="6858000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nl-NL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nl-NL" sz="1000" u="non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000" u="none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o get a more concrete overview of 6-year metabolite changes previously modelled as </a:t>
            </a:r>
            <a:r>
              <a:rPr lang="en-GB" sz="1000" u="none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</a:t>
            </a:r>
            <a:r>
              <a:rPr lang="en-GB" sz="1000" u="none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C scores, we finally compared individual metabolite levels between the two timepoints within study participants using paired t-tests. Out of 680 assessed metabolites, 377 increased in concentration over time, while 142 decreased and 161 remained stable. Xenobiotic per- and polyfluoroalkyl substances (PFAS) ranked among the highest decreasing metabolites, i.e. PFOS, PFOA and PFHxS (SMD = -1.97, -1.13, -0.57 respectively). P-values were corrected for multiple testing using the BH-method. </a:t>
            </a:r>
            <a:r>
              <a:rPr lang="nl-NL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</a:t>
            </a:r>
            <a:r>
              <a:rPr lang="en-GB" sz="1000" b="0" u="none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ext, we sought to identify overrepresented metabolite classes in the increasing, decreasing or stable sets and found that lipids were significantly overrepresented in metabolites which decreased over time (FDR = 4.3x10</a:t>
            </a:r>
            <a:r>
              <a:rPr lang="en-GB" sz="1000" b="0" u="none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0</a:t>
            </a:r>
            <a:r>
              <a:rPr lang="en-GB" sz="1000" b="0" u="none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while amino acids and nucleotides were significantly overrepresented in metabolites which increased over time (FDR = 0.008, FDR = 0.018, respectively)</a:t>
            </a:r>
            <a:endParaRPr lang="nl-NL" sz="1000" b="0" u="non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362055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Afbeelding 2" descr="Afbeelding met zwart, duisternis&#10;&#10;Door AI gegenereerde inhoud is mogelijk onjuist.">
            <a:extLst>
              <a:ext uri="{FF2B5EF4-FFF2-40B4-BE49-F238E27FC236}">
                <a16:creationId xmlns:a16="http://schemas.microsoft.com/office/drawing/2014/main" id="{A3838777-935E-8A80-DF81-CD25C84319D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7004" y="2016522"/>
            <a:ext cx="1541150" cy="1541150"/>
          </a:xfrm>
          <a:prstGeom prst="rect">
            <a:avLst/>
          </a:prstGeom>
        </p:spPr>
      </p:pic>
      <p:pic>
        <p:nvPicPr>
          <p:cNvPr id="8" name="Afbeelding 7" descr="Afbeelding met zwart, duisternis&#10;&#10;Door AI gegenereerde inhoud is mogelijk onjuist.">
            <a:extLst>
              <a:ext uri="{FF2B5EF4-FFF2-40B4-BE49-F238E27FC236}">
                <a16:creationId xmlns:a16="http://schemas.microsoft.com/office/drawing/2014/main" id="{6260CA36-D1DD-B8F3-5655-54729E865DB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6434" y="2016521"/>
            <a:ext cx="1541150" cy="1541150"/>
          </a:xfrm>
          <a:prstGeom prst="rect">
            <a:avLst/>
          </a:prstGeom>
        </p:spPr>
      </p:pic>
      <p:pic>
        <p:nvPicPr>
          <p:cNvPr id="10" name="Afbeelding 9" descr="Afbeelding met zwart, duisternis&#10;&#10;Door AI gegenereerde inhoud is mogelijk onjuist.">
            <a:extLst>
              <a:ext uri="{FF2B5EF4-FFF2-40B4-BE49-F238E27FC236}">
                <a16:creationId xmlns:a16="http://schemas.microsoft.com/office/drawing/2014/main" id="{C1A32787-071D-0F95-235F-0846806F465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6434" y="332622"/>
            <a:ext cx="1541150" cy="1541150"/>
          </a:xfrm>
          <a:prstGeom prst="rect">
            <a:avLst/>
          </a:prstGeom>
        </p:spPr>
      </p:pic>
      <p:pic>
        <p:nvPicPr>
          <p:cNvPr id="12" name="Afbeelding 11" descr="Afbeelding met zwart, duisternis&#10;&#10;Door AI gegenereerde inhoud is mogelijk onjuist.">
            <a:extLst>
              <a:ext uri="{FF2B5EF4-FFF2-40B4-BE49-F238E27FC236}">
                <a16:creationId xmlns:a16="http://schemas.microsoft.com/office/drawing/2014/main" id="{F0FCF028-50EC-02E5-FB81-5DBD0780861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7003" y="332622"/>
            <a:ext cx="1541150" cy="1541150"/>
          </a:xfrm>
          <a:prstGeom prst="rect">
            <a:avLst/>
          </a:prstGeom>
        </p:spPr>
      </p:pic>
      <p:sp>
        <p:nvSpPr>
          <p:cNvPr id="2" name="Tekstvak 1">
            <a:extLst>
              <a:ext uri="{FF2B5EF4-FFF2-40B4-BE49-F238E27FC236}">
                <a16:creationId xmlns:a16="http://schemas.microsoft.com/office/drawing/2014/main" id="{DF8FC68C-F7DA-E8BF-A559-09F4B6B949D8}"/>
              </a:ext>
            </a:extLst>
          </p:cNvPr>
          <p:cNvSpPr txBox="1"/>
          <p:nvPr/>
        </p:nvSpPr>
        <p:spPr>
          <a:xfrm>
            <a:off x="-28297" y="4890"/>
            <a:ext cx="10262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</a:t>
            </a:r>
            <a:r>
              <a:rPr lang="nl-NL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nl-NL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</a:t>
            </a:r>
          </a:p>
        </p:txBody>
      </p:sp>
      <p:sp>
        <p:nvSpPr>
          <p:cNvPr id="13" name="Tekstvak 12">
            <a:extLst>
              <a:ext uri="{FF2B5EF4-FFF2-40B4-BE49-F238E27FC236}">
                <a16:creationId xmlns:a16="http://schemas.microsoft.com/office/drawing/2014/main" id="{A36FA6E1-CEE2-F35C-B7B9-B565DC46055F}"/>
              </a:ext>
            </a:extLst>
          </p:cNvPr>
          <p:cNvSpPr txBox="1"/>
          <p:nvPr/>
        </p:nvSpPr>
        <p:spPr>
          <a:xfrm>
            <a:off x="369479" y="27122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kstvak 13">
            <a:extLst>
              <a:ext uri="{FF2B5EF4-FFF2-40B4-BE49-F238E27FC236}">
                <a16:creationId xmlns:a16="http://schemas.microsoft.com/office/drawing/2014/main" id="{9CE3CCBB-0BEC-8F12-CA3A-55A4925BE7F3}"/>
              </a:ext>
            </a:extLst>
          </p:cNvPr>
          <p:cNvSpPr txBox="1"/>
          <p:nvPr/>
        </p:nvSpPr>
        <p:spPr>
          <a:xfrm>
            <a:off x="346682" y="353261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1" name="Graphic 10">
            <a:extLst>
              <a:ext uri="{FF2B5EF4-FFF2-40B4-BE49-F238E27FC236}">
                <a16:creationId xmlns:a16="http://schemas.microsoft.com/office/drawing/2014/main" id="{A2CA6F35-CC3C-1613-6CDC-709CDDE27F7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rcRect l="16094" t="17355" r="24786" b="17147"/>
          <a:stretch>
            <a:fillRect/>
          </a:stretch>
        </p:blipFill>
        <p:spPr>
          <a:xfrm rot="5400000">
            <a:off x="421350" y="4552362"/>
            <a:ext cx="4432280" cy="2762113"/>
          </a:xfrm>
          <a:prstGeom prst="rect">
            <a:avLst/>
          </a:prstGeom>
        </p:spPr>
      </p:pic>
      <p:sp>
        <p:nvSpPr>
          <p:cNvPr id="684" name="Tekstvak 683">
            <a:extLst>
              <a:ext uri="{FF2B5EF4-FFF2-40B4-BE49-F238E27FC236}">
                <a16:creationId xmlns:a16="http://schemas.microsoft.com/office/drawing/2014/main" id="{B7027752-45DD-24C7-123F-847769E6C219}"/>
              </a:ext>
            </a:extLst>
          </p:cNvPr>
          <p:cNvSpPr txBox="1"/>
          <p:nvPr/>
        </p:nvSpPr>
        <p:spPr>
          <a:xfrm>
            <a:off x="346682" y="794310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686" name="Graphic 685">
            <a:extLst>
              <a:ext uri="{FF2B5EF4-FFF2-40B4-BE49-F238E27FC236}">
                <a16:creationId xmlns:a16="http://schemas.microsoft.com/office/drawing/2014/main" id="{D755BE5C-4B31-7087-AD26-9D31B854FBA4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930953" y="8127773"/>
            <a:ext cx="5372100" cy="2933700"/>
          </a:xfrm>
          <a:prstGeom prst="rect">
            <a:avLst/>
          </a:prstGeom>
        </p:spPr>
      </p:pic>
      <p:sp>
        <p:nvSpPr>
          <p:cNvPr id="5" name="Tekstvak 4">
            <a:extLst>
              <a:ext uri="{FF2B5EF4-FFF2-40B4-BE49-F238E27FC236}">
                <a16:creationId xmlns:a16="http://schemas.microsoft.com/office/drawing/2014/main" id="{A8AE907D-A1D7-C3F9-45A4-ACFE006732D8}"/>
              </a:ext>
            </a:extLst>
          </p:cNvPr>
          <p:cNvSpPr txBox="1"/>
          <p:nvPr/>
        </p:nvSpPr>
        <p:spPr>
          <a:xfrm>
            <a:off x="-28297" y="11366779"/>
            <a:ext cx="6886297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000" b="1" noProof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000" b="0" noProof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tabolite set enrichment analysis score plots (taken from WebgestaltR). Shows enrichment of term-related metabolites along the sorted loading list. </a:t>
            </a:r>
            <a:r>
              <a:rPr lang="en-GB" sz="1000" b="1" noProof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000" b="0" noProof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portions heatmap of Metabolon sub-pathways assigned to each significant metabolite per PC1-5. </a:t>
            </a:r>
            <a:r>
              <a:rPr lang="en-GB" sz="1000" b="1" noProof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</a:t>
            </a:r>
            <a:r>
              <a:rPr lang="en-GB" sz="1000" b="0" noProof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GCNA/ORA results for confirmation of KEGG terms from MSEA and GO analysis.</a:t>
            </a:r>
            <a:endParaRPr lang="en-GB" sz="1000" b="1" noProof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3693434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thema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Kantoorthema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Kantoor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63</TotalTime>
  <Words>326</Words>
  <Application>Microsoft Office PowerPoint</Application>
  <PresentationFormat>Breedbeeld</PresentationFormat>
  <Paragraphs>34</Paragraphs>
  <Slides>4</Slides>
  <Notes>4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4</vt:i4>
      </vt:variant>
      <vt:variant>
        <vt:lpstr>Thema</vt:lpstr>
      </vt:variant>
      <vt:variant>
        <vt:i4>1</vt:i4>
      </vt:variant>
      <vt:variant>
        <vt:lpstr>Diatitel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Times New Roman</vt:lpstr>
      <vt:lpstr>Kantoorthema</vt:lpstr>
      <vt:lpstr>PowerPoint-presentatie</vt:lpstr>
      <vt:lpstr>PowerPoint-presentatie</vt:lpstr>
      <vt:lpstr>PowerPoint-presentatie</vt:lpstr>
      <vt:lpstr>PowerPoint-presentati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lose, D. (Dennis)</dc:creator>
  <cp:lastModifiedBy>Klose, D. (Dennis)</cp:lastModifiedBy>
  <cp:revision>26</cp:revision>
  <cp:lastPrinted>2025-05-07T12:54:47Z</cp:lastPrinted>
  <dcterms:created xsi:type="dcterms:W3CDTF">2025-04-25T12:39:41Z</dcterms:created>
  <dcterms:modified xsi:type="dcterms:W3CDTF">2026-07-10T15:12:45Z</dcterms:modified>
</cp:coreProperties>
</file>